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7" r:id="rId2"/>
    <p:sldId id="262" r:id="rId3"/>
    <p:sldId id="266" r:id="rId4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340" autoAdjust="0"/>
  </p:normalViewPr>
  <p:slideViewPr>
    <p:cSldViewPr snapToGrid="0">
      <p:cViewPr varScale="1">
        <p:scale>
          <a:sx n="84" d="100"/>
          <a:sy n="84" d="100"/>
        </p:scale>
        <p:origin x="65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1BED8A-BF01-43B4-A4CA-9CECAE9BFCE1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90CFCF-EA79-4CBD-9BDB-9B0F66BB3D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678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D347901-0069-35F1-18F8-54B7C1D61C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430FB3BB-6C68-1807-EE39-898C214B91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B5AEE8D-817A-735E-9F2D-5BBA9E92C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A44ADCC-A22B-4B1B-2F90-2C3F554B2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C099DF2-73F4-BA18-A5D7-5A373B2C0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540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B60FD09-198F-0B89-00A7-DDBAA3ED0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7419A8E7-48D7-9DE6-27F4-684497BE2F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8B7C62D-1118-D256-F6B1-6E9E7C054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86BA16E-9557-965B-91B7-6C9023B62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2F54101A-DD3A-90A5-687E-66958ED1B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431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F0F8E00A-53F2-8E5D-6BD6-8553BFD31C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102F5E53-A3BA-C576-7335-15C24CFC2D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9AD098F-C484-F990-409A-A7323C864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CECB79D-2A0C-B89C-3A59-6AC59BC7B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9B91778-FABE-A84F-C109-56AD3DBB0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286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D7071DC-55E2-C818-A8AE-F8C7B0754F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90CA8656-2535-D685-B3B0-244B3B63D5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D9761A5-FD8B-D7A1-A32B-B17A6ECA2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2AFF290-8733-6667-E1DD-D9F636F85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F81890B-CE84-2A27-0C68-FAE99AF4F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143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6277B6B-5B7B-A760-5D39-39C0B3205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2355F460-49A3-C6C5-D985-FB4526B97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B300D54-0813-541D-0F72-FE6DC3920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3FA0966-B591-E5BC-91C0-B05A2B14E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CE52BB6-0BF9-3493-06D2-8B85BBB5E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1939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59ABD2A-1BA0-2855-685D-354B18D24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59098333-950C-143C-5313-A921617C76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CD4A4F85-7BE6-BD34-0C48-77537C9EE6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49D0949-A799-CB1E-7540-0267C4092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E2F2FF6-33E8-818D-593F-FB7837F89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4AEBB90E-A09C-D6A3-5B30-5784705B2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744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F0B3C83-BD59-8F0C-9C68-E5F13EF47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3B7F1BE-08F3-4394-02B3-957AB45BE7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2FE47EE-489A-C0DC-106D-48126C6D3C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9FE7178E-A4FB-3223-3531-B31C391D47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F50B3F53-1D3F-6300-99FB-AA9100B15F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966280B-598C-BA0A-E853-9124F590F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30367C78-DDDA-2D32-34B9-186B9038A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8C96EB7A-A5BC-015F-98E7-315CBC080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232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CC2FEEF-7A3C-BB94-F9C8-BCF0F0860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8115AA15-6056-403C-A4F5-0B2937CF5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7631E7D2-FD99-6AE0-E88F-50BC2D09F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D40BDC48-3E15-E6B1-269E-584203D02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267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8152A7AE-3258-6B56-2F02-B5C784968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F0E8DCF1-B129-F3B6-0BA5-B80C9D587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A146BCD7-2297-AC37-FB6F-E60BD63E7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42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51DB637-A499-AB05-6731-255E8A4DA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EF2B169-A8A0-A1F6-F13F-AFADB18860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7F6DF9F0-B7A7-2378-FED6-E22039271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40C930E-C9E1-E2C4-C2CC-21F82C31DF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3DBF0BE-C25E-8CCB-474E-8A089CC48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E12BC71A-CF0B-7982-AE4B-A35EC8314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965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79CC606-6D43-EDA0-27FF-F7B1F95A0B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09E0F376-A406-7400-DF75-A899089137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7DBDF74B-58DD-1082-703F-7E6F6463CC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B233ECF-E1B2-1242-CED2-46EC041BA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766587C-2372-73A2-6330-2327347B9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DE941CC-8163-2BF0-3B67-F7DC8B9A7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572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72553425-C2F6-9219-EB4D-D340E7696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E98430F6-0C4A-355C-D7C7-D6D3637C9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28CC16E-FC51-4853-0E9B-47EA97BA43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EBD664-C974-424D-AC19-DBFC46CAD58F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50E1EEE-BB9A-3D92-6A22-CD86E5703C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2FC9F48-B361-B0DB-599D-2AAF4B13D3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53405F-E13F-49E0-8065-04DBDE2AF5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393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>
            <a:extLst>
              <a:ext uri="{FF2B5EF4-FFF2-40B4-BE49-F238E27FC236}">
                <a16:creationId xmlns:a16="http://schemas.microsoft.com/office/drawing/2014/main" xmlns="" id="{06B6DDBB-0EDF-0BDC-E9B7-4F5C9D1F0D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7713" y="3766900"/>
            <a:ext cx="3830919" cy="2631674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xmlns="" id="{577FC406-4A5C-02CB-EAA7-7949F6D2CB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1637" y="370336"/>
            <a:ext cx="3837514" cy="2653367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xmlns="" id="{A58C25A1-9298-4441-2435-14C897F8C1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3468" y="3818428"/>
            <a:ext cx="3857338" cy="2667074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xmlns="" id="{073B9C20-1332-0EAF-E6F0-39EAA0C227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3468" y="371576"/>
            <a:ext cx="3857338" cy="266707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510E95F-58DB-5869-C7D0-DEFCF3BE09E2}"/>
              </a:ext>
            </a:extLst>
          </p:cNvPr>
          <p:cNvSpPr txBox="1"/>
          <p:nvPr/>
        </p:nvSpPr>
        <p:spPr>
          <a:xfrm>
            <a:off x="2111704" y="521732"/>
            <a:ext cx="23509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.3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, 4.2–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.6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xmlns="" id="{BE3D9D06-7755-20B4-56C0-D6B47D11B284}"/>
              </a:ext>
            </a:extLst>
          </p:cNvPr>
          <p:cNvCxnSpPr/>
          <p:nvPr/>
        </p:nvCxnSpPr>
        <p:spPr>
          <a:xfrm>
            <a:off x="7235622" y="4040094"/>
            <a:ext cx="31805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xmlns="" id="{C581AD7E-47A8-8F10-DD23-27A7ED362FC7}"/>
              </a:ext>
            </a:extLst>
          </p:cNvPr>
          <p:cNvCxnSpPr/>
          <p:nvPr/>
        </p:nvCxnSpPr>
        <p:spPr>
          <a:xfrm>
            <a:off x="7235622" y="4212311"/>
            <a:ext cx="318052" cy="0"/>
          </a:xfrm>
          <a:prstGeom prst="line">
            <a:avLst/>
          </a:prstGeom>
          <a:ln/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xmlns="" id="{159C5C1A-714B-6CF4-39F9-9BC3CCEE40D8}"/>
              </a:ext>
            </a:extLst>
          </p:cNvPr>
          <p:cNvCxnSpPr/>
          <p:nvPr/>
        </p:nvCxnSpPr>
        <p:spPr>
          <a:xfrm>
            <a:off x="7235622" y="4391275"/>
            <a:ext cx="318052" cy="0"/>
          </a:xfrm>
          <a:prstGeom prst="line">
            <a:avLst/>
          </a:prstGeom>
          <a:ln/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C50A6A1A-FA66-15E2-EB8B-F5D3963A17C0}"/>
              </a:ext>
            </a:extLst>
          </p:cNvPr>
          <p:cNvSpPr txBox="1"/>
          <p:nvPr/>
        </p:nvSpPr>
        <p:spPr>
          <a:xfrm>
            <a:off x="7542146" y="3884516"/>
            <a:ext cx="23823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 25.9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, 10.7–30.1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56B6F93E-9191-67C6-A860-5DA900186CB7}"/>
              </a:ext>
            </a:extLst>
          </p:cNvPr>
          <p:cNvSpPr txBox="1"/>
          <p:nvPr/>
        </p:nvSpPr>
        <p:spPr>
          <a:xfrm>
            <a:off x="7542148" y="4063872"/>
            <a:ext cx="2329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10.1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, 8.4–13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9FFE071F-D223-896E-E54F-DC2BF1EC4304}"/>
              </a:ext>
            </a:extLst>
          </p:cNvPr>
          <p:cNvSpPr txBox="1"/>
          <p:nvPr/>
        </p:nvSpPr>
        <p:spPr>
          <a:xfrm>
            <a:off x="7562024" y="4246027"/>
            <a:ext cx="23791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3rd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  8.6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, 4.0–20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E270E161-7F75-1475-0681-3B5D515D2DB8}"/>
              </a:ext>
            </a:extLst>
          </p:cNvPr>
          <p:cNvSpPr txBox="1"/>
          <p:nvPr/>
        </p:nvSpPr>
        <p:spPr>
          <a:xfrm>
            <a:off x="0" y="-1399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189ADCCF-E416-2983-9983-8C8B00675760}"/>
              </a:ext>
            </a:extLst>
          </p:cNvPr>
          <p:cNvSpPr txBox="1"/>
          <p:nvPr/>
        </p:nvSpPr>
        <p:spPr>
          <a:xfrm>
            <a:off x="432424" y="134033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CC55ADE0-1BFF-1247-C62B-C6B83AAAA1E7}"/>
              </a:ext>
            </a:extLst>
          </p:cNvPr>
          <p:cNvSpPr txBox="1"/>
          <p:nvPr/>
        </p:nvSpPr>
        <p:spPr>
          <a:xfrm>
            <a:off x="5775127" y="159957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xmlns="" id="{93392C71-3DA6-1720-13EA-5C5255B99030}"/>
              </a:ext>
            </a:extLst>
          </p:cNvPr>
          <p:cNvCxnSpPr/>
          <p:nvPr/>
        </p:nvCxnSpPr>
        <p:spPr>
          <a:xfrm>
            <a:off x="7283850" y="591669"/>
            <a:ext cx="31805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327573E7-64B7-ABC4-0C87-CD879FBCF769}"/>
              </a:ext>
            </a:extLst>
          </p:cNvPr>
          <p:cNvCxnSpPr/>
          <p:nvPr/>
        </p:nvCxnSpPr>
        <p:spPr>
          <a:xfrm>
            <a:off x="7283850" y="763886"/>
            <a:ext cx="318052" cy="0"/>
          </a:xfrm>
          <a:prstGeom prst="line">
            <a:avLst/>
          </a:prstGeom>
          <a:ln/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xmlns="" id="{CD1D995C-A960-8884-BA06-746CE42E82B5}"/>
              </a:ext>
            </a:extLst>
          </p:cNvPr>
          <p:cNvCxnSpPr/>
          <p:nvPr/>
        </p:nvCxnSpPr>
        <p:spPr>
          <a:xfrm>
            <a:off x="7283850" y="942850"/>
            <a:ext cx="318052" cy="0"/>
          </a:xfrm>
          <a:prstGeom prst="line">
            <a:avLst/>
          </a:prstGeom>
          <a:ln/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F7932AB7-40FA-47F3-218F-08516CE25420}"/>
              </a:ext>
            </a:extLst>
          </p:cNvPr>
          <p:cNvSpPr txBox="1"/>
          <p:nvPr/>
        </p:nvSpPr>
        <p:spPr>
          <a:xfrm>
            <a:off x="7592695" y="472587"/>
            <a:ext cx="2254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 5.9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9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–11.0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29862FDF-5B4B-45FC-8388-3924FFC8E629}"/>
              </a:ext>
            </a:extLst>
          </p:cNvPr>
          <p:cNvSpPr txBox="1"/>
          <p:nvPr/>
        </p:nvSpPr>
        <p:spPr>
          <a:xfrm>
            <a:off x="7592697" y="651943"/>
            <a:ext cx="21980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3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4.1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–6.3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396E12C0-0F03-8BD0-350A-9447CE9654BD}"/>
              </a:ext>
            </a:extLst>
          </p:cNvPr>
          <p:cNvSpPr txBox="1"/>
          <p:nvPr/>
        </p:nvSpPr>
        <p:spPr>
          <a:xfrm>
            <a:off x="7612573" y="834098"/>
            <a:ext cx="2311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3rd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6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ths (95% CI, 1.9–2.8)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0E83D0A5-A300-2A8B-EB42-E333843A0F1C}"/>
              </a:ext>
            </a:extLst>
          </p:cNvPr>
          <p:cNvSpPr txBox="1"/>
          <p:nvPr/>
        </p:nvSpPr>
        <p:spPr>
          <a:xfrm>
            <a:off x="432424" y="3447406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0CFEE551-A730-2AE0-D854-18C4A174C6CB}"/>
              </a:ext>
            </a:extLst>
          </p:cNvPr>
          <p:cNvSpPr txBox="1"/>
          <p:nvPr/>
        </p:nvSpPr>
        <p:spPr>
          <a:xfrm>
            <a:off x="5784200" y="3527595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2219200F-3AA1-7FF7-2D1A-581E3D1C5ADE}"/>
              </a:ext>
            </a:extLst>
          </p:cNvPr>
          <p:cNvSpPr txBox="1"/>
          <p:nvPr/>
        </p:nvSpPr>
        <p:spPr>
          <a:xfrm>
            <a:off x="2133322" y="3978561"/>
            <a:ext cx="23509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.0 months (95% CI, 8.8–14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42A540CB-660F-2F0F-C8B7-1E410918B519}"/>
              </a:ext>
            </a:extLst>
          </p:cNvPr>
          <p:cNvSpPr txBox="1"/>
          <p:nvPr/>
        </p:nvSpPr>
        <p:spPr>
          <a:xfrm>
            <a:off x="6123719" y="3006165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119548FE-AD7E-5F02-6A8A-2A44FD980D88}"/>
              </a:ext>
            </a:extLst>
          </p:cNvPr>
          <p:cNvSpPr txBox="1"/>
          <p:nvPr/>
        </p:nvSpPr>
        <p:spPr>
          <a:xfrm>
            <a:off x="6089674" y="3170981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88C97F47-F714-8EDA-616F-5CAAC2045D58}"/>
              </a:ext>
            </a:extLst>
          </p:cNvPr>
          <p:cNvSpPr txBox="1"/>
          <p:nvPr/>
        </p:nvSpPr>
        <p:spPr>
          <a:xfrm>
            <a:off x="6605695" y="3024058"/>
            <a:ext cx="3486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             1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8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0              0             0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9572C965-F478-43CB-A53E-A34E5B5BA977}"/>
              </a:ext>
            </a:extLst>
          </p:cNvPr>
          <p:cNvSpPr txBox="1"/>
          <p:nvPr/>
        </p:nvSpPr>
        <p:spPr>
          <a:xfrm>
            <a:off x="6605695" y="3180313"/>
            <a:ext cx="3557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rabicPlain" startAt="70"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4              7             6             4              2             0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D03B4463-B2AE-2D16-F3C8-AAE5644B2829}"/>
              </a:ext>
            </a:extLst>
          </p:cNvPr>
          <p:cNvSpPr txBox="1"/>
          <p:nvPr/>
        </p:nvSpPr>
        <p:spPr>
          <a:xfrm>
            <a:off x="5467206" y="299426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98CC0FFA-1D29-021F-2089-343AC059BF45}"/>
              </a:ext>
            </a:extLst>
          </p:cNvPr>
          <p:cNvSpPr txBox="1"/>
          <p:nvPr/>
        </p:nvSpPr>
        <p:spPr>
          <a:xfrm>
            <a:off x="6023527" y="3331160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3rd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3C9216B7-007A-4E58-3E0E-8DC81DABE5A5}"/>
              </a:ext>
            </a:extLst>
          </p:cNvPr>
          <p:cNvSpPr txBox="1"/>
          <p:nvPr/>
        </p:nvSpPr>
        <p:spPr>
          <a:xfrm>
            <a:off x="6613437" y="3321976"/>
            <a:ext cx="34547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              2              2             0             0              0             0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6B16A954-E53A-7023-11C5-87160A1E4F30}"/>
              </a:ext>
            </a:extLst>
          </p:cNvPr>
          <p:cNvSpPr txBox="1"/>
          <p:nvPr/>
        </p:nvSpPr>
        <p:spPr>
          <a:xfrm>
            <a:off x="6061925" y="6336219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9DD89F23-8550-A761-3369-711E0C947F54}"/>
              </a:ext>
            </a:extLst>
          </p:cNvPr>
          <p:cNvSpPr txBox="1"/>
          <p:nvPr/>
        </p:nvSpPr>
        <p:spPr>
          <a:xfrm>
            <a:off x="6026386" y="6509960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E9BFFB14-F29B-0778-8C0B-0F01A61B2D48}"/>
              </a:ext>
            </a:extLst>
          </p:cNvPr>
          <p:cNvSpPr txBox="1"/>
          <p:nvPr/>
        </p:nvSpPr>
        <p:spPr>
          <a:xfrm>
            <a:off x="6543901" y="6354112"/>
            <a:ext cx="3486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             26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20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0              0              0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25A5E596-22C7-9D2E-3EEC-A7F9F4F98763}"/>
              </a:ext>
            </a:extLst>
          </p:cNvPr>
          <p:cNvSpPr txBox="1"/>
          <p:nvPr/>
        </p:nvSpPr>
        <p:spPr>
          <a:xfrm>
            <a:off x="6536159" y="6510315"/>
            <a:ext cx="36215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rabicPlain" startAt="70"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35             21            15             6              6              0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DD2708E4-C775-89D0-6D4A-08CAFFD00F28}"/>
              </a:ext>
            </a:extLst>
          </p:cNvPr>
          <p:cNvSpPr txBox="1"/>
          <p:nvPr/>
        </p:nvSpPr>
        <p:spPr>
          <a:xfrm>
            <a:off x="5408040" y="633621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C0521AAD-A5C9-FC10-5454-3FA32E7AAC4C}"/>
              </a:ext>
            </a:extLst>
          </p:cNvPr>
          <p:cNvSpPr txBox="1"/>
          <p:nvPr/>
        </p:nvSpPr>
        <p:spPr>
          <a:xfrm>
            <a:off x="5953991" y="6661162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3rd lin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00E09FE0-15DA-151B-5549-8D85F97525C0}"/>
              </a:ext>
            </a:extLst>
          </p:cNvPr>
          <p:cNvSpPr txBox="1"/>
          <p:nvPr/>
        </p:nvSpPr>
        <p:spPr>
          <a:xfrm>
            <a:off x="6543901" y="6661214"/>
            <a:ext cx="34547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              4              2              0              0              0              0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5165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xmlns="" id="{4B00D784-8940-8822-241E-E2925B6847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089" y="810034"/>
            <a:ext cx="4318955" cy="296693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42ACD488-105A-C5A0-3135-87DE1A0A3DFD}"/>
              </a:ext>
            </a:extLst>
          </p:cNvPr>
          <p:cNvSpPr txBox="1"/>
          <p:nvPr/>
        </p:nvSpPr>
        <p:spPr>
          <a:xfrm>
            <a:off x="272207" y="126115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78CE42D8-40C1-5A69-DA56-65C287F66CA9}"/>
              </a:ext>
            </a:extLst>
          </p:cNvPr>
          <p:cNvSpPr txBox="1"/>
          <p:nvPr/>
        </p:nvSpPr>
        <p:spPr>
          <a:xfrm>
            <a:off x="3525254" y="2016013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8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-rank test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xmlns="" id="{C1C3B4E2-D018-99F1-F5B3-EDAFAE67E50C}"/>
              </a:ext>
            </a:extLst>
          </p:cNvPr>
          <p:cNvCxnSpPr/>
          <p:nvPr/>
        </p:nvCxnSpPr>
        <p:spPr>
          <a:xfrm>
            <a:off x="3775191" y="1813368"/>
            <a:ext cx="526472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96E75002-E725-9C06-1835-A76E062BC864}"/>
              </a:ext>
            </a:extLst>
          </p:cNvPr>
          <p:cNvCxnSpPr/>
          <p:nvPr/>
        </p:nvCxnSpPr>
        <p:spPr>
          <a:xfrm>
            <a:off x="3775191" y="1633259"/>
            <a:ext cx="52647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EA3CA06-EFD8-AB31-3A3C-A88790600E65}"/>
              </a:ext>
            </a:extLst>
          </p:cNvPr>
          <p:cNvSpPr txBox="1"/>
          <p:nvPr/>
        </p:nvSpPr>
        <p:spPr>
          <a:xfrm>
            <a:off x="4301661" y="1438060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A1DBA9DF-AEA6-C54C-68D4-CDB8A927B7FD}"/>
              </a:ext>
            </a:extLst>
          </p:cNvPr>
          <p:cNvSpPr txBox="1"/>
          <p:nvPr/>
        </p:nvSpPr>
        <p:spPr>
          <a:xfrm>
            <a:off x="4301662" y="1658633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10C3BD4F-AEC5-7F27-D5AD-821380CBA911}"/>
              </a:ext>
            </a:extLst>
          </p:cNvPr>
          <p:cNvSpPr txBox="1"/>
          <p:nvPr/>
        </p:nvSpPr>
        <p:spPr>
          <a:xfrm>
            <a:off x="1750375" y="3747477"/>
            <a:ext cx="36856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7                9              10             10             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A77D4808-E59B-D433-34F2-AD52534A1C5F}"/>
              </a:ext>
            </a:extLst>
          </p:cNvPr>
          <p:cNvSpPr txBox="1"/>
          <p:nvPr/>
        </p:nvSpPr>
        <p:spPr>
          <a:xfrm>
            <a:off x="1676487" y="3996187"/>
            <a:ext cx="3724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0              29              35             35             35             3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29B0C33C-1DDD-7D44-D4C0-34FB0DF8E2F7}"/>
              </a:ext>
            </a:extLst>
          </p:cNvPr>
          <p:cNvSpPr txBox="1"/>
          <p:nvPr/>
        </p:nvSpPr>
        <p:spPr>
          <a:xfrm>
            <a:off x="166270" y="3764553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33A8B4AE-3C8C-73DC-54D3-F54D6D264EB2}"/>
              </a:ext>
            </a:extLst>
          </p:cNvPr>
          <p:cNvSpPr txBox="1"/>
          <p:nvPr/>
        </p:nvSpPr>
        <p:spPr>
          <a:xfrm>
            <a:off x="1017955" y="3758819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24836B32-0176-88FC-2AFB-59F1D082B837}"/>
              </a:ext>
            </a:extLst>
          </p:cNvPr>
          <p:cNvSpPr txBox="1"/>
          <p:nvPr/>
        </p:nvSpPr>
        <p:spPr>
          <a:xfrm>
            <a:off x="994712" y="4025677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20926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図 61">
            <a:extLst>
              <a:ext uri="{FF2B5EF4-FFF2-40B4-BE49-F238E27FC236}">
                <a16:creationId xmlns:a16="http://schemas.microsoft.com/office/drawing/2014/main" xmlns="" id="{FE585770-D1A7-DFFD-A04B-A41926F2C8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2047" y="831303"/>
            <a:ext cx="3537320" cy="2395271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xmlns="" id="{49E13929-3F4F-AD04-8498-E5EB49F5D6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38805" y="3801513"/>
            <a:ext cx="3442624" cy="2364932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xmlns="" id="{6F1969B7-573A-1886-2CF7-0D0B5F2BA6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3104" y="3791486"/>
            <a:ext cx="3494448" cy="240053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xmlns="" id="{7D3FCBF5-D117-AF86-6C04-6D04CD377A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76042" y="835584"/>
            <a:ext cx="3464061" cy="237965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D8041334-1619-F923-D7BB-1DD772A490A9}"/>
              </a:ext>
            </a:extLst>
          </p:cNvPr>
          <p:cNvSpPr txBox="1"/>
          <p:nvPr/>
        </p:nvSpPr>
        <p:spPr>
          <a:xfrm>
            <a:off x="89742" y="-41436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67748EF6-DE36-0039-D075-F783023B776E}"/>
              </a:ext>
            </a:extLst>
          </p:cNvPr>
          <p:cNvSpPr txBox="1"/>
          <p:nvPr/>
        </p:nvSpPr>
        <p:spPr>
          <a:xfrm>
            <a:off x="848903" y="66598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699C920A-0E71-7BC1-B7A1-41F0B6CCE3D2}"/>
              </a:ext>
            </a:extLst>
          </p:cNvPr>
          <p:cNvSpPr txBox="1"/>
          <p:nvPr/>
        </p:nvSpPr>
        <p:spPr>
          <a:xfrm>
            <a:off x="5665439" y="605028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056D1BC8-E941-34B4-5A2F-75D9C5B38704}"/>
              </a:ext>
            </a:extLst>
          </p:cNvPr>
          <p:cNvSpPr txBox="1"/>
          <p:nvPr/>
        </p:nvSpPr>
        <p:spPr>
          <a:xfrm>
            <a:off x="1125351" y="3226574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79FF6A41-AB90-3A09-BC66-C03AA7029D7E}"/>
              </a:ext>
            </a:extLst>
          </p:cNvPr>
          <p:cNvSpPr txBox="1"/>
          <p:nvPr/>
        </p:nvSpPr>
        <p:spPr>
          <a:xfrm>
            <a:off x="1134846" y="3380740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D893C2D9-F0D6-2282-535C-555117E8F769}"/>
              </a:ext>
            </a:extLst>
          </p:cNvPr>
          <p:cNvSpPr txBox="1"/>
          <p:nvPr/>
        </p:nvSpPr>
        <p:spPr>
          <a:xfrm>
            <a:off x="1607327" y="3244467"/>
            <a:ext cx="3038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               4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1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46135CD1-DF6D-296E-9E35-0941CA83E551}"/>
              </a:ext>
            </a:extLst>
          </p:cNvPr>
          <p:cNvSpPr txBox="1"/>
          <p:nvPr/>
        </p:nvSpPr>
        <p:spPr>
          <a:xfrm>
            <a:off x="1599585" y="3409906"/>
            <a:ext cx="3038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               6              2              0               0              0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1F2483BF-37C3-1B46-2742-D20B09041EF2}"/>
              </a:ext>
            </a:extLst>
          </p:cNvPr>
          <p:cNvSpPr txBox="1"/>
          <p:nvPr/>
        </p:nvSpPr>
        <p:spPr>
          <a:xfrm>
            <a:off x="5747753" y="3187230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FF50FE8E-C538-DC06-16F8-5E5184BE0328}"/>
              </a:ext>
            </a:extLst>
          </p:cNvPr>
          <p:cNvSpPr txBox="1"/>
          <p:nvPr/>
        </p:nvSpPr>
        <p:spPr>
          <a:xfrm>
            <a:off x="5748426" y="3340002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60885788-982C-3591-9411-9309750F047D}"/>
              </a:ext>
            </a:extLst>
          </p:cNvPr>
          <p:cNvSpPr txBox="1"/>
          <p:nvPr/>
        </p:nvSpPr>
        <p:spPr>
          <a:xfrm>
            <a:off x="6330581" y="3204277"/>
            <a:ext cx="31021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             1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3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1 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ADD8D94E-EB1E-2885-AD2D-0FA7B31B199C}"/>
              </a:ext>
            </a:extLst>
          </p:cNvPr>
          <p:cNvSpPr txBox="1"/>
          <p:nvPr/>
        </p:nvSpPr>
        <p:spPr>
          <a:xfrm>
            <a:off x="6332494" y="3340867"/>
            <a:ext cx="3038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             16              6               3               0               0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B945C795-AB90-12DB-55EB-B710950BFFF4}"/>
              </a:ext>
            </a:extLst>
          </p:cNvPr>
          <p:cNvSpPr txBox="1"/>
          <p:nvPr/>
        </p:nvSpPr>
        <p:spPr>
          <a:xfrm>
            <a:off x="2697556" y="1238201"/>
            <a:ext cx="14285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9 (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-rank test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367857E4-BDD8-EE76-1BFA-CC2F0E51125F}"/>
              </a:ext>
            </a:extLst>
          </p:cNvPr>
          <p:cNvSpPr txBox="1"/>
          <p:nvPr/>
        </p:nvSpPr>
        <p:spPr>
          <a:xfrm>
            <a:off x="2351093" y="1440988"/>
            <a:ext cx="21675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HR 1.4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6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.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)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7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xmlns="" id="{C3BE21EF-8418-95C9-9B37-8C47B1E6CC1C}"/>
              </a:ext>
            </a:extLst>
          </p:cNvPr>
          <p:cNvCxnSpPr/>
          <p:nvPr/>
        </p:nvCxnSpPr>
        <p:spPr>
          <a:xfrm>
            <a:off x="2972189" y="1103629"/>
            <a:ext cx="526472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xmlns="" id="{D5E3F565-4236-AF07-26EE-1660ED4E0286}"/>
              </a:ext>
            </a:extLst>
          </p:cNvPr>
          <p:cNvCxnSpPr/>
          <p:nvPr/>
        </p:nvCxnSpPr>
        <p:spPr>
          <a:xfrm>
            <a:off x="2972189" y="977780"/>
            <a:ext cx="52647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0E9C00C5-952A-C684-01CE-7B17956AFBCE}"/>
              </a:ext>
            </a:extLst>
          </p:cNvPr>
          <p:cNvSpPr txBox="1"/>
          <p:nvPr/>
        </p:nvSpPr>
        <p:spPr>
          <a:xfrm>
            <a:off x="3495814" y="844681"/>
            <a:ext cx="5517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67AB1DF4-FF4C-2250-1DCE-3B69431C42AD}"/>
              </a:ext>
            </a:extLst>
          </p:cNvPr>
          <p:cNvSpPr txBox="1"/>
          <p:nvPr/>
        </p:nvSpPr>
        <p:spPr>
          <a:xfrm>
            <a:off x="3498660" y="1013835"/>
            <a:ext cx="5822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E550483C-3D4F-F5CE-8CFB-88BAC7480FB0}"/>
              </a:ext>
            </a:extLst>
          </p:cNvPr>
          <p:cNvSpPr txBox="1"/>
          <p:nvPr/>
        </p:nvSpPr>
        <p:spPr>
          <a:xfrm>
            <a:off x="7673694" y="1274971"/>
            <a:ext cx="13420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1(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-rank tes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CA854E3F-D398-91A0-7D67-C948E9B76E83}"/>
              </a:ext>
            </a:extLst>
          </p:cNvPr>
          <p:cNvSpPr txBox="1"/>
          <p:nvPr/>
        </p:nvSpPr>
        <p:spPr>
          <a:xfrm>
            <a:off x="7323987" y="1482818"/>
            <a:ext cx="20746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HR 1.39 (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.84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1"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56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xmlns="" id="{66322778-80DB-2BFA-8D1D-7E9F8FCA141A}"/>
              </a:ext>
            </a:extLst>
          </p:cNvPr>
          <p:cNvCxnSpPr/>
          <p:nvPr/>
        </p:nvCxnSpPr>
        <p:spPr>
          <a:xfrm>
            <a:off x="7910327" y="1140739"/>
            <a:ext cx="526472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xmlns="" id="{AE438E1D-E6EE-AF17-BE59-CA44B0005148}"/>
              </a:ext>
            </a:extLst>
          </p:cNvPr>
          <p:cNvCxnSpPr/>
          <p:nvPr/>
        </p:nvCxnSpPr>
        <p:spPr>
          <a:xfrm>
            <a:off x="7910327" y="1023548"/>
            <a:ext cx="52647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C7FB647F-504F-1942-E272-2725C8479C5C}"/>
              </a:ext>
            </a:extLst>
          </p:cNvPr>
          <p:cNvSpPr txBox="1"/>
          <p:nvPr/>
        </p:nvSpPr>
        <p:spPr>
          <a:xfrm>
            <a:off x="8433952" y="882080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-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19FEC8FB-E6BB-157A-7A76-7ED5F0F44809}"/>
              </a:ext>
            </a:extLst>
          </p:cNvPr>
          <p:cNvSpPr txBox="1"/>
          <p:nvPr/>
        </p:nvSpPr>
        <p:spPr>
          <a:xfrm>
            <a:off x="8436798" y="1023526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x(+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xmlns="" id="{0CAE75C5-585E-71D2-5B80-6100C477174C}"/>
              </a:ext>
            </a:extLst>
          </p:cNvPr>
          <p:cNvCxnSpPr/>
          <p:nvPr/>
        </p:nvCxnSpPr>
        <p:spPr>
          <a:xfrm>
            <a:off x="2982731" y="4106640"/>
            <a:ext cx="526472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xmlns="" id="{9C32CF48-881E-D3F2-34C6-42D2922E5A2C}"/>
              </a:ext>
            </a:extLst>
          </p:cNvPr>
          <p:cNvCxnSpPr/>
          <p:nvPr/>
        </p:nvCxnSpPr>
        <p:spPr>
          <a:xfrm>
            <a:off x="2982731" y="3971555"/>
            <a:ext cx="52647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A474FF63-08EA-93C9-7D09-A29DAF2DB731}"/>
              </a:ext>
            </a:extLst>
          </p:cNvPr>
          <p:cNvSpPr txBox="1"/>
          <p:nvPr/>
        </p:nvSpPr>
        <p:spPr>
          <a:xfrm>
            <a:off x="3506356" y="3801512"/>
            <a:ext cx="6110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5C1BB7D4-9A69-1C0F-4E9E-24D1925F5180}"/>
              </a:ext>
            </a:extLst>
          </p:cNvPr>
          <p:cNvSpPr txBox="1"/>
          <p:nvPr/>
        </p:nvSpPr>
        <p:spPr>
          <a:xfrm>
            <a:off x="3509202" y="3989138"/>
            <a:ext cx="5806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DAC47F48-A91C-0334-8BC8-EA6453620402}"/>
              </a:ext>
            </a:extLst>
          </p:cNvPr>
          <p:cNvSpPr txBox="1"/>
          <p:nvPr/>
        </p:nvSpPr>
        <p:spPr>
          <a:xfrm>
            <a:off x="2745878" y="4236808"/>
            <a:ext cx="14285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1 (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-rank test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A92E97CA-02FE-42E0-FB77-55235DEAFB8B}"/>
              </a:ext>
            </a:extLst>
          </p:cNvPr>
          <p:cNvSpPr txBox="1"/>
          <p:nvPr/>
        </p:nvSpPr>
        <p:spPr>
          <a:xfrm>
            <a:off x="2388266" y="4454271"/>
            <a:ext cx="21675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HR 1.4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.11-2.67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4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xmlns="" id="{8DF23E26-9400-EFC6-3EF2-CEF8F9DA6A57}"/>
              </a:ext>
            </a:extLst>
          </p:cNvPr>
          <p:cNvCxnSpPr/>
          <p:nvPr/>
        </p:nvCxnSpPr>
        <p:spPr>
          <a:xfrm>
            <a:off x="7837666" y="4096780"/>
            <a:ext cx="526472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xmlns="" id="{78C83E30-940A-BDCB-8C56-96C356F8446D}"/>
              </a:ext>
            </a:extLst>
          </p:cNvPr>
          <p:cNvCxnSpPr/>
          <p:nvPr/>
        </p:nvCxnSpPr>
        <p:spPr>
          <a:xfrm>
            <a:off x="7837666" y="3961695"/>
            <a:ext cx="52647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A9B8257F-DFFC-D4FB-FA5D-04FFEEB9ED81}"/>
              </a:ext>
            </a:extLst>
          </p:cNvPr>
          <p:cNvSpPr txBox="1"/>
          <p:nvPr/>
        </p:nvSpPr>
        <p:spPr>
          <a:xfrm>
            <a:off x="8361291" y="3828596"/>
            <a:ext cx="6110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33EDB5A3-7790-56F9-2155-BE3395C810B2}"/>
              </a:ext>
            </a:extLst>
          </p:cNvPr>
          <p:cNvSpPr txBox="1"/>
          <p:nvPr/>
        </p:nvSpPr>
        <p:spPr>
          <a:xfrm>
            <a:off x="8364137" y="3970042"/>
            <a:ext cx="5806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C4EF504E-FC6D-07EE-9039-5A52E80F2035}"/>
              </a:ext>
            </a:extLst>
          </p:cNvPr>
          <p:cNvSpPr txBox="1"/>
          <p:nvPr/>
        </p:nvSpPr>
        <p:spPr>
          <a:xfrm>
            <a:off x="7447477" y="4179234"/>
            <a:ext cx="14285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31 (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-rank test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835CA3BC-D8B1-AADA-AF03-863CCDF2A178}"/>
              </a:ext>
            </a:extLst>
          </p:cNvPr>
          <p:cNvSpPr txBox="1"/>
          <p:nvPr/>
        </p:nvSpPr>
        <p:spPr>
          <a:xfrm>
            <a:off x="7097297" y="4379190"/>
            <a:ext cx="21675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HR 1.6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.31-2.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)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32BA9FA0-80F9-3133-BDD8-6F8819BCE53F}"/>
              </a:ext>
            </a:extLst>
          </p:cNvPr>
          <p:cNvSpPr txBox="1"/>
          <p:nvPr/>
        </p:nvSpPr>
        <p:spPr>
          <a:xfrm>
            <a:off x="1001049" y="6185343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68C8FBC7-F274-BB63-258A-AFBA00DBC6AC}"/>
              </a:ext>
            </a:extLst>
          </p:cNvPr>
          <p:cNvSpPr txBox="1"/>
          <p:nvPr/>
        </p:nvSpPr>
        <p:spPr>
          <a:xfrm>
            <a:off x="1005257" y="6343503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552CFE3F-E9C9-6F28-2068-CC8AC2AE04DA}"/>
              </a:ext>
            </a:extLst>
          </p:cNvPr>
          <p:cNvSpPr txBox="1"/>
          <p:nvPr/>
        </p:nvSpPr>
        <p:spPr>
          <a:xfrm>
            <a:off x="1599541" y="6168262"/>
            <a:ext cx="3038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           10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2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1   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D9A6C2A8-FDA6-A741-8472-E305A91C0417}"/>
              </a:ext>
            </a:extLst>
          </p:cNvPr>
          <p:cNvSpPr txBox="1"/>
          <p:nvPr/>
        </p:nvSpPr>
        <p:spPr>
          <a:xfrm>
            <a:off x="1599541" y="6346023"/>
            <a:ext cx="3038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            5              1               0              0               0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16D6ABA6-7411-01B0-A897-4439038B3070}"/>
              </a:ext>
            </a:extLst>
          </p:cNvPr>
          <p:cNvSpPr txBox="1"/>
          <p:nvPr/>
        </p:nvSpPr>
        <p:spPr>
          <a:xfrm>
            <a:off x="5886153" y="6167308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1771615C-F439-A762-E41A-2B742FCADC3D}"/>
              </a:ext>
            </a:extLst>
          </p:cNvPr>
          <p:cNvSpPr txBox="1"/>
          <p:nvPr/>
        </p:nvSpPr>
        <p:spPr>
          <a:xfrm>
            <a:off x="5876590" y="631963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4C5380BF-A324-FCA9-0D4B-31E354C00B2E}"/>
              </a:ext>
            </a:extLst>
          </p:cNvPr>
          <p:cNvSpPr txBox="1"/>
          <p:nvPr/>
        </p:nvSpPr>
        <p:spPr>
          <a:xfrm>
            <a:off x="6441418" y="6167309"/>
            <a:ext cx="3070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           12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8               4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2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2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86A81897-7030-4018-A0E3-C8F5A53591C4}"/>
              </a:ext>
            </a:extLst>
          </p:cNvPr>
          <p:cNvSpPr txBox="1"/>
          <p:nvPr/>
        </p:nvSpPr>
        <p:spPr>
          <a:xfrm>
            <a:off x="6450655" y="6293183"/>
            <a:ext cx="3294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           10             2               1              0               0       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6E8D8044-47CE-53AF-7DF4-83818633026B}"/>
              </a:ext>
            </a:extLst>
          </p:cNvPr>
          <p:cNvSpPr txBox="1"/>
          <p:nvPr/>
        </p:nvSpPr>
        <p:spPr>
          <a:xfrm>
            <a:off x="379976" y="618534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42151233-E875-0099-4F40-0647B54905D4}"/>
              </a:ext>
            </a:extLst>
          </p:cNvPr>
          <p:cNvSpPr txBox="1"/>
          <p:nvPr/>
        </p:nvSpPr>
        <p:spPr>
          <a:xfrm>
            <a:off x="5252768" y="617515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DFE9B85F-12C3-2E95-978A-54887C524515}"/>
              </a:ext>
            </a:extLst>
          </p:cNvPr>
          <p:cNvSpPr txBox="1"/>
          <p:nvPr/>
        </p:nvSpPr>
        <p:spPr>
          <a:xfrm>
            <a:off x="436396" y="321524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F4E8F235-8233-2225-46A0-29ABF0FE3A79}"/>
              </a:ext>
            </a:extLst>
          </p:cNvPr>
          <p:cNvSpPr txBox="1"/>
          <p:nvPr/>
        </p:nvSpPr>
        <p:spPr>
          <a:xfrm>
            <a:off x="5015715" y="316855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187F7983-D169-82FE-94AA-8CAD0848520B}"/>
              </a:ext>
            </a:extLst>
          </p:cNvPr>
          <p:cNvSpPr txBox="1"/>
          <p:nvPr/>
        </p:nvSpPr>
        <p:spPr>
          <a:xfrm>
            <a:off x="850901" y="3553328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D77CABCD-47B8-3727-9EB7-3E80083AD0A7}"/>
              </a:ext>
            </a:extLst>
          </p:cNvPr>
          <p:cNvSpPr txBox="1"/>
          <p:nvPr/>
        </p:nvSpPr>
        <p:spPr>
          <a:xfrm>
            <a:off x="5778526" y="3656127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7962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971</TotalTime>
  <Words>351</Words>
  <Application>Microsoft Office PowerPoint</Application>
  <PresentationFormat>Widescreen</PresentationFormat>
  <Paragraphs>7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源 今井</dc:creator>
  <cp:lastModifiedBy>Kumari Vinayagam</cp:lastModifiedBy>
  <cp:revision>15</cp:revision>
  <cp:lastPrinted>2025-06-05T03:09:32Z</cp:lastPrinted>
  <dcterms:created xsi:type="dcterms:W3CDTF">2025-04-17T07:40:23Z</dcterms:created>
  <dcterms:modified xsi:type="dcterms:W3CDTF">2026-04-06T06:50:40Z</dcterms:modified>
</cp:coreProperties>
</file>